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B95E7"/>
    <a:srgbClr val="EBC4F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71" autoAdjust="0"/>
    <p:restoredTop sz="96357" autoAdjust="0"/>
  </p:normalViewPr>
  <p:slideViewPr>
    <p:cSldViewPr snapToGrid="0">
      <p:cViewPr varScale="1">
        <p:scale>
          <a:sx n="106" d="100"/>
          <a:sy n="106" d="100"/>
        </p:scale>
        <p:origin x="1140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256CEF-5E8A-4BA0-8740-35143FB8323A}" type="datetimeFigureOut">
              <a:rPr lang="es-MX" smtClean="0"/>
              <a:t>11/01/2022</a:t>
            </a:fld>
            <a:endParaRPr lang="es-MX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D51FE3-4ECA-4DA2-A8DF-185149D2DAD1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6991344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MX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D51FE3-4ECA-4DA2-A8DF-185149D2DAD1}" type="slidenum">
              <a:rPr lang="es-MX" smtClean="0"/>
              <a:t>1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1421097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A4E59-A2CC-4D08-B7D9-5B76C451F95A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9109B-D87E-41EB-BADE-9426BF29E7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5399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A4E59-A2CC-4D08-B7D9-5B76C451F95A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9109B-D87E-41EB-BADE-9426BF29E7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900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A4E59-A2CC-4D08-B7D9-5B76C451F95A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9109B-D87E-41EB-BADE-9426BF29E7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743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A4E59-A2CC-4D08-B7D9-5B76C451F95A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9109B-D87E-41EB-BADE-9426BF29E7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0350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A4E59-A2CC-4D08-B7D9-5B76C451F95A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9109B-D87E-41EB-BADE-9426BF29E7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2311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A4E59-A2CC-4D08-B7D9-5B76C451F95A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9109B-D87E-41EB-BADE-9426BF29E7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8044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A4E59-A2CC-4D08-B7D9-5B76C451F95A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9109B-D87E-41EB-BADE-9426BF29E7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0726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A4E59-A2CC-4D08-B7D9-5B76C451F95A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9109B-D87E-41EB-BADE-9426BF29E7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1639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A4E59-A2CC-4D08-B7D9-5B76C451F95A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9109B-D87E-41EB-BADE-9426BF29E7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2803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A4E59-A2CC-4D08-B7D9-5B76C451F95A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9109B-D87E-41EB-BADE-9426BF29E7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5510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A4E59-A2CC-4D08-B7D9-5B76C451F95A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99109B-D87E-41EB-BADE-9426BF29E7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28287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2A4E59-A2CC-4D08-B7D9-5B76C451F95A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99109B-D87E-41EB-BADE-9426BF29E7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94962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1.jpeg"/><Relationship Id="rId7" Type="http://schemas.microsoft.com/office/2007/relationships/hdphoto" Target="../media/hdphoto1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7.png"/><Relationship Id="rId5" Type="http://schemas.openxmlformats.org/officeDocument/2006/relationships/image" Target="../media/image3.png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/>
          <p:cNvSpPr/>
          <p:nvPr/>
        </p:nvSpPr>
        <p:spPr>
          <a:xfrm>
            <a:off x="482137" y="232748"/>
            <a:ext cx="2842953" cy="781397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Prior to MIDO COVID implementation</a:t>
            </a:r>
          </a:p>
        </p:txBody>
      </p:sp>
      <p:sp>
        <p:nvSpPr>
          <p:cNvPr id="5" name="Rectángulo 4"/>
          <p:cNvSpPr/>
          <p:nvPr/>
        </p:nvSpPr>
        <p:spPr>
          <a:xfrm>
            <a:off x="3693622" y="232748"/>
            <a:ext cx="8402584" cy="781397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During MIDO COVID implementation</a:t>
            </a:r>
          </a:p>
        </p:txBody>
      </p:sp>
      <p:sp>
        <p:nvSpPr>
          <p:cNvPr id="6" name="Rectángulo 5"/>
          <p:cNvSpPr/>
          <p:nvPr/>
        </p:nvSpPr>
        <p:spPr>
          <a:xfrm>
            <a:off x="497966" y="1180443"/>
            <a:ext cx="2842953" cy="2980518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Online certification of</a:t>
            </a:r>
          </a:p>
          <a:p>
            <a:pPr algn="ctr"/>
            <a:r>
              <a:rPr lang="en-US" dirty="0"/>
              <a:t>MIDO Expert staff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/>
              <a:t>Standardization of procedur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/>
              <a:t>Training in taking accurate measurement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/>
              <a:t>Use of MIDO COVID digital health solution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/>
              <a:t>Standardization of counseling and results communication and epidemiology protocol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s-MX" sz="1400" dirty="0"/>
              <a:t>Use </a:t>
            </a:r>
            <a:r>
              <a:rPr lang="en-US" sz="1400" dirty="0"/>
              <a:t>of</a:t>
            </a:r>
            <a:r>
              <a:rPr lang="es-MX" sz="1400" dirty="0"/>
              <a:t> personal </a:t>
            </a:r>
            <a:r>
              <a:rPr lang="en-US" sz="1400" dirty="0"/>
              <a:t>protective equipment  </a:t>
            </a:r>
          </a:p>
          <a:p>
            <a:pPr algn="ctr"/>
            <a:endParaRPr lang="en-US" dirty="0"/>
          </a:p>
        </p:txBody>
      </p:sp>
      <p:sp>
        <p:nvSpPr>
          <p:cNvPr id="7" name="Rectángulo 6"/>
          <p:cNvSpPr/>
          <p:nvPr/>
        </p:nvSpPr>
        <p:spPr>
          <a:xfrm>
            <a:off x="497966" y="4327259"/>
            <a:ext cx="2842953" cy="1028006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All employees register in MONITOR application to have an ID to be tracked by MIDO COVID   </a:t>
            </a:r>
          </a:p>
        </p:txBody>
      </p:sp>
      <p:sp>
        <p:nvSpPr>
          <p:cNvPr id="8" name="Rectángulo 7"/>
          <p:cNvSpPr/>
          <p:nvPr/>
        </p:nvSpPr>
        <p:spPr>
          <a:xfrm>
            <a:off x="3693622" y="1198802"/>
            <a:ext cx="2402378" cy="1028006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Return of workers without COVID symptoms to workplace </a:t>
            </a:r>
          </a:p>
        </p:txBody>
      </p:sp>
      <p:sp>
        <p:nvSpPr>
          <p:cNvPr id="9" name="Rectángulo 8"/>
          <p:cNvSpPr/>
          <p:nvPr/>
        </p:nvSpPr>
        <p:spPr>
          <a:xfrm>
            <a:off x="6299069" y="1198802"/>
            <a:ext cx="3107772" cy="2218087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MIDO COVID application at workplace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/>
              <a:t>Detection of chronic disease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400" dirty="0"/>
              <a:t>Diabetes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400" dirty="0"/>
              <a:t>Hypertension 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400" dirty="0"/>
              <a:t>Obesit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/>
              <a:t>COVID antibody test, temperature and pulse oximetry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400" dirty="0"/>
              <a:t>Suspected active infection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400" dirty="0"/>
              <a:t>Suspected previous infection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1400" dirty="0"/>
              <a:t>No infection suspected</a:t>
            </a:r>
          </a:p>
        </p:txBody>
      </p:sp>
      <p:sp>
        <p:nvSpPr>
          <p:cNvPr id="10" name="Rectángulo 9"/>
          <p:cNvSpPr/>
          <p:nvPr/>
        </p:nvSpPr>
        <p:spPr>
          <a:xfrm>
            <a:off x="482137" y="5521563"/>
            <a:ext cx="2842953" cy="1028006"/>
          </a:xfrm>
          <a:prstGeom prst="rect">
            <a:avLst/>
          </a:prstGeom>
          <a:solidFill>
            <a:srgbClr val="EBC4F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Designation and set up of a safe space to evaluate workers at the workplace</a:t>
            </a:r>
          </a:p>
        </p:txBody>
      </p:sp>
      <p:sp>
        <p:nvSpPr>
          <p:cNvPr id="11" name="Rectángulo 10"/>
          <p:cNvSpPr/>
          <p:nvPr/>
        </p:nvSpPr>
        <p:spPr>
          <a:xfrm>
            <a:off x="9609910" y="1198802"/>
            <a:ext cx="2486296" cy="1953701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400" dirty="0"/>
              <a:t>Immediate results and counseling for worke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/>
              <a:t>MIDO profile individual recommendations for chronic disease detection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/>
              <a:t>Specific epidemiology protocol for suspected active COVID infection</a:t>
            </a:r>
          </a:p>
        </p:txBody>
      </p:sp>
      <p:sp>
        <p:nvSpPr>
          <p:cNvPr id="12" name="Rectángulo 11"/>
          <p:cNvSpPr/>
          <p:nvPr/>
        </p:nvSpPr>
        <p:spPr>
          <a:xfrm>
            <a:off x="9609910" y="3331580"/>
            <a:ext cx="2486296" cy="1275806"/>
          </a:xfrm>
          <a:prstGeom prst="rect">
            <a:avLst/>
          </a:prstGeom>
          <a:solidFill>
            <a:srgbClr val="DB95E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400" dirty="0"/>
              <a:t>Real-time results available at an executive dashboard for decision making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/>
              <a:t>COVID outbreak detect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/>
              <a:t>Implementation of health strategies in the workplace</a:t>
            </a:r>
          </a:p>
        </p:txBody>
      </p:sp>
      <p:sp>
        <p:nvSpPr>
          <p:cNvPr id="13" name="Rectángulo 12"/>
          <p:cNvSpPr/>
          <p:nvPr/>
        </p:nvSpPr>
        <p:spPr>
          <a:xfrm>
            <a:off x="3693622" y="2388883"/>
            <a:ext cx="2402378" cy="1028006"/>
          </a:xfrm>
          <a:prstGeom prst="rect">
            <a:avLst/>
          </a:prstGeom>
          <a:solidFill>
            <a:srgbClr val="DB95E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Guarantee of availability of tests and supplies</a:t>
            </a:r>
          </a:p>
        </p:txBody>
      </p:sp>
      <p:sp>
        <p:nvSpPr>
          <p:cNvPr id="14" name="CuadroTexto 13"/>
          <p:cNvSpPr txBox="1"/>
          <p:nvPr/>
        </p:nvSpPr>
        <p:spPr>
          <a:xfrm>
            <a:off x="9151051" y="5547050"/>
            <a:ext cx="2945155" cy="1079398"/>
          </a:xfrm>
          <a:prstGeom prst="rect">
            <a:avLst/>
          </a:prstGeom>
          <a:noFill/>
          <a:ln>
            <a:solidFill>
              <a:schemeClr val="tx1"/>
            </a:solidFill>
            <a:prstDash val="lgDash"/>
          </a:ln>
        </p:spPr>
        <p:txBody>
          <a:bodyPr wrap="square" rtlCol="0">
            <a:spAutoFit/>
          </a:bodyPr>
          <a:lstStyle/>
          <a:p>
            <a:r>
              <a:rPr lang="en-US" sz="1200" dirty="0"/>
              <a:t>Activities done by:</a:t>
            </a:r>
          </a:p>
          <a:p>
            <a:pPr marL="171450" indent="-1714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200" dirty="0"/>
              <a:t>MIDO Experts</a:t>
            </a:r>
          </a:p>
          <a:p>
            <a:pPr marL="171450" indent="-1714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200" dirty="0"/>
              <a:t>Workers</a:t>
            </a:r>
          </a:p>
          <a:p>
            <a:pPr marL="171450" indent="-1714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200" dirty="0"/>
              <a:t>Managers</a:t>
            </a:r>
          </a:p>
        </p:txBody>
      </p:sp>
      <p:sp>
        <p:nvSpPr>
          <p:cNvPr id="15" name="Rectángulo 14"/>
          <p:cNvSpPr/>
          <p:nvPr/>
        </p:nvSpPr>
        <p:spPr>
          <a:xfrm>
            <a:off x="10369026" y="6385890"/>
            <a:ext cx="1022604" cy="197168"/>
          </a:xfrm>
          <a:prstGeom prst="rect">
            <a:avLst/>
          </a:prstGeom>
          <a:gradFill flip="none" rotWithShape="1">
            <a:gsLst>
              <a:gs pos="0">
                <a:srgbClr val="DB95E7">
                  <a:tint val="66000"/>
                  <a:satMod val="160000"/>
                </a:srgbClr>
              </a:gs>
              <a:gs pos="50000">
                <a:srgbClr val="DB95E7">
                  <a:tint val="44500"/>
                  <a:satMod val="160000"/>
                </a:srgbClr>
              </a:gs>
              <a:gs pos="100000">
                <a:srgbClr val="DB95E7">
                  <a:tint val="23500"/>
                  <a:satMod val="160000"/>
                </a:srgbClr>
              </a:gs>
            </a:gsLst>
            <a:lin ang="108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ángulo 15"/>
          <p:cNvSpPr/>
          <p:nvPr/>
        </p:nvSpPr>
        <p:spPr>
          <a:xfrm>
            <a:off x="10369026" y="5857241"/>
            <a:ext cx="1022604" cy="197168"/>
          </a:xfrm>
          <a:prstGeom prst="rect">
            <a:avLst/>
          </a:prstGeom>
          <a:gradFill flip="none" rotWithShape="1">
            <a:gsLst>
              <a:gs pos="0">
                <a:schemeClr val="accent2">
                  <a:lumMod val="60000"/>
                  <a:lumOff val="40000"/>
                  <a:tint val="66000"/>
                  <a:satMod val="160000"/>
                </a:schemeClr>
              </a:gs>
              <a:gs pos="50000">
                <a:schemeClr val="accent2">
                  <a:lumMod val="60000"/>
                  <a:lumOff val="40000"/>
                  <a:tint val="44500"/>
                  <a:satMod val="160000"/>
                </a:schemeClr>
              </a:gs>
              <a:gs pos="100000">
                <a:schemeClr val="accent2">
                  <a:lumMod val="60000"/>
                  <a:lumOff val="40000"/>
                  <a:tint val="23500"/>
                  <a:satMod val="160000"/>
                </a:schemeClr>
              </a:gs>
            </a:gsLst>
            <a:lin ang="108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ángulo 16"/>
          <p:cNvSpPr/>
          <p:nvPr/>
        </p:nvSpPr>
        <p:spPr>
          <a:xfrm>
            <a:off x="10369026" y="6117039"/>
            <a:ext cx="1022604" cy="197168"/>
          </a:xfrm>
          <a:prstGeom prst="rect">
            <a:avLst/>
          </a:prstGeom>
          <a:gradFill flip="none" rotWithShape="1">
            <a:gsLst>
              <a:gs pos="0">
                <a:schemeClr val="accent6">
                  <a:lumMod val="60000"/>
                  <a:lumOff val="40000"/>
                  <a:tint val="66000"/>
                  <a:satMod val="160000"/>
                </a:schemeClr>
              </a:gs>
              <a:gs pos="50000">
                <a:schemeClr val="accent6">
                  <a:lumMod val="60000"/>
                  <a:lumOff val="40000"/>
                  <a:tint val="44500"/>
                  <a:satMod val="160000"/>
                </a:schemeClr>
              </a:gs>
              <a:gs pos="100000">
                <a:schemeClr val="accent6">
                  <a:lumMod val="60000"/>
                  <a:lumOff val="40000"/>
                  <a:tint val="23500"/>
                  <a:satMod val="160000"/>
                </a:schemeClr>
              </a:gs>
            </a:gsLst>
            <a:lin ang="108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Elipse 2"/>
          <p:cNvSpPr/>
          <p:nvPr/>
        </p:nvSpPr>
        <p:spPr>
          <a:xfrm>
            <a:off x="5111932" y="4107809"/>
            <a:ext cx="304800" cy="30480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MX" dirty="0"/>
              <a:t>1</a:t>
            </a:r>
            <a:endParaRPr lang="en-US" dirty="0"/>
          </a:p>
        </p:txBody>
      </p:sp>
      <p:sp>
        <p:nvSpPr>
          <p:cNvPr id="18" name="Elipse 17"/>
          <p:cNvSpPr/>
          <p:nvPr/>
        </p:nvSpPr>
        <p:spPr>
          <a:xfrm>
            <a:off x="6327869" y="4107809"/>
            <a:ext cx="304800" cy="30480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MX" dirty="0"/>
              <a:t>2</a:t>
            </a:r>
            <a:endParaRPr lang="en-US" dirty="0"/>
          </a:p>
        </p:txBody>
      </p:sp>
      <p:sp>
        <p:nvSpPr>
          <p:cNvPr id="19" name="Elipse 18"/>
          <p:cNvSpPr/>
          <p:nvPr/>
        </p:nvSpPr>
        <p:spPr>
          <a:xfrm>
            <a:off x="7543806" y="4107809"/>
            <a:ext cx="304800" cy="30480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MX" dirty="0"/>
              <a:t>3</a:t>
            </a:r>
            <a:endParaRPr lang="en-US" dirty="0"/>
          </a:p>
        </p:txBody>
      </p:sp>
      <p:sp>
        <p:nvSpPr>
          <p:cNvPr id="20" name="Elipse 19"/>
          <p:cNvSpPr/>
          <p:nvPr/>
        </p:nvSpPr>
        <p:spPr>
          <a:xfrm>
            <a:off x="8646528" y="4113881"/>
            <a:ext cx="304800" cy="30480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MX" dirty="0"/>
              <a:t>4</a:t>
            </a:r>
            <a:endParaRPr lang="en-US" dirty="0"/>
          </a:p>
        </p:txBody>
      </p:sp>
      <p:pic>
        <p:nvPicPr>
          <p:cNvPr id="21" name="Picture 2" descr="https://cloudprivacycheck.eu/fileadmin/templates/assets/cpc/steps/step-1.jpg"/>
          <p:cNvPicPr>
            <a:picLocks noChangeAspect="1" noChangeArrowheads="1"/>
          </p:cNvPicPr>
          <p:nvPr/>
        </p:nvPicPr>
        <p:blipFill>
          <a:blip r:embed="rId3" cstate="print">
            <a:duotone>
              <a:schemeClr val="accent2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99501" y="4502226"/>
            <a:ext cx="695532" cy="6955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4" descr="https://www.shareicon.net/data/2015/10/03/111405_measurement_512x512.png"/>
          <p:cNvPicPr>
            <a:picLocks noChangeAspect="1" noChangeArrowheads="1"/>
          </p:cNvPicPr>
          <p:nvPr/>
        </p:nvPicPr>
        <p:blipFill>
          <a:blip r:embed="rId4" cstate="print">
            <a:duotone>
              <a:schemeClr val="accent2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62383" y="5329603"/>
            <a:ext cx="743205" cy="7432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6" descr="https://www.thisisant.com/assets/images/profiles/Blood-Pressure-Monitor.png"/>
          <p:cNvPicPr>
            <a:picLocks noChangeAspect="1" noChangeArrowheads="1"/>
          </p:cNvPicPr>
          <p:nvPr/>
        </p:nvPicPr>
        <p:blipFill>
          <a:blip r:embed="rId5" cstate="print">
            <a:duotone>
              <a:schemeClr val="accent2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1060" y="4605919"/>
            <a:ext cx="726401" cy="5391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2" descr="Comprobación de la temperatura corporal en un área pública | Vector Premium"/>
          <p:cNvPicPr>
            <a:picLocks noChangeAspect="1" noChangeArrowheads="1"/>
          </p:cNvPicPr>
          <p:nvPr/>
        </p:nvPicPr>
        <p:blipFill>
          <a:blip r:embed="rId6" cstate="print">
            <a:duotone>
              <a:schemeClr val="accent2">
                <a:shade val="45000"/>
                <a:satMod val="135000"/>
              </a:schemeClr>
              <a:prstClr val="white"/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ackgroundRemoval t="6805" b="94083" l="5030" r="95562">
                        <a14:foregroundMark x1="18935" y1="46154" x2="18935" y2="46154"/>
                        <a14:foregroundMark x1="31065" y1="33728" x2="31065" y2="33728"/>
                        <a14:foregroundMark x1="36391" y1="29882" x2="36391" y2="29882"/>
                        <a14:foregroundMark x1="26331" y1="31065" x2="26331" y2="31065"/>
                        <a14:foregroundMark x1="25740" y1="35799" x2="25740" y2="35799"/>
                        <a14:foregroundMark x1="25148" y1="37870" x2="25148" y2="37870"/>
                        <a14:foregroundMark x1="22485" y1="37278" x2="22485" y2="37278"/>
                        <a14:foregroundMark x1="22189" y1="30473" x2="22189" y2="30473"/>
                        <a14:foregroundMark x1="40533" y1="76331" x2="40533" y2="76331"/>
                        <a14:foregroundMark x1="61538" y1="42604" x2="61538" y2="42604"/>
                        <a14:foregroundMark x1="58876" y1="39941" x2="58876" y2="39941"/>
                        <a14:foregroundMark x1="56213" y1="56805" x2="56213" y2="56805"/>
                        <a14:foregroundMark x1="21006" y1="60355" x2="21006" y2="60355"/>
                        <a14:foregroundMark x1="29882" y1="59467" x2="29882" y2="59467"/>
                        <a14:foregroundMark x1="33728" y1="67456" x2="33728" y2="67456"/>
                        <a14:foregroundMark x1="36686" y1="70414" x2="36686" y2="70414"/>
                        <a14:foregroundMark x1="37278" y1="53254" x2="37278" y2="53254"/>
                        <a14:foregroundMark x1="37278" y1="46154" x2="37278" y2="46154"/>
                        <a14:foregroundMark x1="38757" y1="39941" x2="39349" y2="38462"/>
                        <a14:foregroundMark x1="40533" y1="34615" x2="40533" y2="34615"/>
                        <a14:foregroundMark x1="40533" y1="34615" x2="40533" y2="34615"/>
                        <a14:foregroundMark x1="39349" y1="21006" x2="39349" y2="21006"/>
                        <a14:foregroundMark x1="39349" y1="21006" x2="39349" y2="21006"/>
                        <a14:foregroundMark x1="39349" y1="21006" x2="39349" y2="21006"/>
                        <a14:foregroundMark x1="38462" y1="20414" x2="38462" y2="20414"/>
                        <a14:foregroundMark x1="44675" y1="17456" x2="44675" y2="17456"/>
                        <a14:foregroundMark x1="46746" y1="17456" x2="46746" y2="17456"/>
                        <a14:foregroundMark x1="49408" y1="16864" x2="50888" y2="16272"/>
                        <a14:foregroundMark x1="57396" y1="15680" x2="57396" y2="15680"/>
                        <a14:foregroundMark x1="59467" y1="15385" x2="59467" y2="15385"/>
                        <a14:foregroundMark x1="61538" y1="15385" x2="61538" y2="15385"/>
                        <a14:foregroundMark x1="66864" y1="18343" x2="66864" y2="18343"/>
                        <a14:foregroundMark x1="67160" y1="18935" x2="67160" y2="18935"/>
                        <a14:foregroundMark x1="68343" y1="19527" x2="70414" y2="21006"/>
                        <a14:foregroundMark x1="73077" y1="22485" x2="76331" y2="25740"/>
                        <a14:foregroundMark x1="77219" y1="29586" x2="79882" y2="37870"/>
                        <a14:foregroundMark x1="79882" y1="39349" x2="79882" y2="41124"/>
                        <a14:foregroundMark x1="80473" y1="46154" x2="80473" y2="46154"/>
                        <a14:foregroundMark x1="80473" y1="47337" x2="81065" y2="49408"/>
                        <a14:foregroundMark x1="81065" y1="50592" x2="81065" y2="53254"/>
                        <a14:foregroundMark x1="81361" y1="55325" x2="81953" y2="57988"/>
                        <a14:foregroundMark x1="81953" y1="58284" x2="81953" y2="58284"/>
                        <a14:foregroundMark x1="82544" y1="39349" x2="82544" y2="39349"/>
                        <a14:foregroundMark x1="83136" y1="33728" x2="83136" y2="33728"/>
                        <a14:foregroundMark x1="79882" y1="27219" x2="79882" y2="27219"/>
                        <a14:foregroundMark x1="81361" y1="26923" x2="81953" y2="28994"/>
                        <a14:foregroundMark x1="85207" y1="37870" x2="85207" y2="37870"/>
                        <a14:foregroundMark x1="26331" y1="79882" x2="26331" y2="79882"/>
                        <a14:foregroundMark x1="26331" y1="68343" x2="26331" y2="68343"/>
                        <a14:foregroundMark x1="26331" y1="68343" x2="26331" y2="68343"/>
                        <a14:foregroundMark x1="25148" y1="65680" x2="25148" y2="65680"/>
                        <a14:foregroundMark x1="19527" y1="57396" x2="19527" y2="57396"/>
                        <a14:foregroundMark x1="18935" y1="55621" x2="18935" y2="55621"/>
                        <a14:foregroundMark x1="18935" y1="54142" x2="18935" y2="54142"/>
                        <a14:foregroundMark x1="18343" y1="53550" x2="18343" y2="53550"/>
                        <a14:foregroundMark x1="13609" y1="57396" x2="13609" y2="57396"/>
                        <a14:foregroundMark x1="13609" y1="57988" x2="13609" y2="57988"/>
                        <a14:foregroundMark x1="19822" y1="62722" x2="19822" y2="62722"/>
                        <a14:foregroundMark x1="20414" y1="64201" x2="20414" y2="64201"/>
                        <a14:foregroundMark x1="16864" y1="64201" x2="16864" y2="64201"/>
                        <a14:foregroundMark x1="16864" y1="65680" x2="16864" y2="65680"/>
                        <a14:foregroundMark x1="21006" y1="73077" x2="21006" y2="73077"/>
                        <a14:foregroundMark x1="21598" y1="73669" x2="21598" y2="73669"/>
                        <a14:foregroundMark x1="23669" y1="73669" x2="25740" y2="73669"/>
                        <a14:foregroundMark x1="26923" y1="74556" x2="26923" y2="74556"/>
                        <a14:foregroundMark x1="27811" y1="74556" x2="27811" y2="74556"/>
                        <a14:foregroundMark x1="29290" y1="75148" x2="29290" y2="75148"/>
                        <a14:foregroundMark x1="29882" y1="76331" x2="29882" y2="76331"/>
                        <a14:foregroundMark x1="29882" y1="73669" x2="29882" y2="73669"/>
                        <a14:foregroundMark x1="29882" y1="68343" x2="29882" y2="68343"/>
                        <a14:foregroundMark x1="29882" y1="68343" x2="29882" y2="68343"/>
                        <a14:foregroundMark x1="26923" y1="73077" x2="26923" y2="73077"/>
                        <a14:foregroundMark x1="30473" y1="83136" x2="30473" y2="83136"/>
                        <a14:foregroundMark x1="30473" y1="20414" x2="30473" y2="20414"/>
                        <a14:foregroundMark x1="30473" y1="20414" x2="30473" y2="20414"/>
                        <a14:foregroundMark x1="30473" y1="20414" x2="30473" y2="20414"/>
                        <a14:foregroundMark x1="35799" y1="21006" x2="35799" y2="21006"/>
                        <a14:foregroundMark x1="35799" y1="21006" x2="35799" y2="21006"/>
                        <a14:foregroundMark x1="34615" y1="24260" x2="34615" y2="24260"/>
                        <a14:foregroundMark x1="30473" y1="23669" x2="30473" y2="23669"/>
                        <a14:foregroundMark x1="27811" y1="23669" x2="27811" y2="23669"/>
                        <a14:foregroundMark x1="25740" y1="23669" x2="25740" y2="23669"/>
                        <a14:foregroundMark x1="14793" y1="36686" x2="14793" y2="36686"/>
                        <a14:foregroundMark x1="16272" y1="39053" x2="16272" y2="39053"/>
                        <a14:foregroundMark x1="16272" y1="39053" x2="16272" y2="39053"/>
                        <a14:foregroundMark x1="17751" y1="35799" x2="17751" y2="35799"/>
                        <a14:foregroundMark x1="17751" y1="33728" x2="17751" y2="33728"/>
                        <a14:foregroundMark x1="18343" y1="33728" x2="18343" y2="33728"/>
                        <a14:foregroundMark x1="22189" y1="28994" x2="22189" y2="28994"/>
                        <a14:foregroundMark x1="22485" y1="28994" x2="22485" y2="28994"/>
                        <a14:foregroundMark x1="24556" y1="25740" x2="24556" y2="25740"/>
                        <a14:foregroundMark x1="25148" y1="25148" x2="25148" y2="25148"/>
                        <a14:foregroundMark x1="26331" y1="24852" x2="26331" y2="24852"/>
                        <a14:foregroundMark x1="38757" y1="18343" x2="38757" y2="18343"/>
                        <a14:foregroundMark x1="38757" y1="18343" x2="38757" y2="18343"/>
                        <a14:foregroundMark x1="39349" y1="17751" x2="39349" y2="17751"/>
                        <a14:foregroundMark x1="39349" y1="17751" x2="39349" y2="17751"/>
                        <a14:foregroundMark x1="40533" y1="17456" x2="40533" y2="17456"/>
                        <a14:foregroundMark x1="42012" y1="20118" x2="42012" y2="20118"/>
                        <a14:foregroundMark x1="31953" y1="65680" x2="31953" y2="65680"/>
                        <a14:foregroundMark x1="20414" y1="68935" x2="20414" y2="68935"/>
                        <a14:foregroundMark x1="20414" y1="68935" x2="20414" y2="68935"/>
                        <a14:foregroundMark x1="15089" y1="62130" x2="15089" y2="62130"/>
                        <a14:foregroundMark x1="14793" y1="61538" x2="14793" y2="61538"/>
                        <a14:foregroundMark x1="13018" y1="42604" x2="13018" y2="42604"/>
                        <a14:foregroundMark x1="14793" y1="42604" x2="14793" y2="42604"/>
                        <a14:foregroundMark x1="17456" y1="41124" x2="17456" y2="41124"/>
                        <a14:foregroundMark x1="19527" y1="33728" x2="19527" y2="33728"/>
                        <a14:foregroundMark x1="19527" y1="33136" x2="19527" y2="33136"/>
                        <a14:foregroundMark x1="19822" y1="32544" x2="19822" y2="32544"/>
                        <a14:foregroundMark x1="19822" y1="32544" x2="19822" y2="32544"/>
                        <a14:foregroundMark x1="19822" y1="32544" x2="19822" y2="32544"/>
                        <a14:foregroundMark x1="24556" y1="27811" x2="24556" y2="27811"/>
                        <a14:foregroundMark x1="19527" y1="28994" x2="19527" y2="28994"/>
                        <a14:foregroundMark x1="19822" y1="68935" x2="19822" y2="68935"/>
                        <a14:foregroundMark x1="21598" y1="71598" x2="21598" y2="71598"/>
                        <a14:foregroundMark x1="23669" y1="76331" x2="23669" y2="76331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9680" y="5230233"/>
            <a:ext cx="847781" cy="8477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8" descr="Pulsioxímetro en el dedo. dispositivo digital para medir la saturación de  oxígeno. | Vector Premium"/>
          <p:cNvPicPr>
            <a:picLocks noChangeAspect="1" noChangeArrowheads="1"/>
          </p:cNvPicPr>
          <p:nvPr/>
        </p:nvPicPr>
        <p:blipFill>
          <a:blip r:embed="rId8" cstate="print">
            <a:duotone>
              <a:schemeClr val="accent2">
                <a:shade val="45000"/>
                <a:satMod val="135000"/>
              </a:schemeClr>
              <a:prstClr val="white"/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ackgroundRemoval t="9763" b="100000" l="9772" r="89902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7187907">
            <a:off x="3883973" y="6052022"/>
            <a:ext cx="700024" cy="7707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Abrir llave 25"/>
          <p:cNvSpPr/>
          <p:nvPr/>
        </p:nvSpPr>
        <p:spPr>
          <a:xfrm rot="5400000">
            <a:off x="6834218" y="1791957"/>
            <a:ext cx="418268" cy="3992287"/>
          </a:xfrm>
          <a:prstGeom prst="leftBrace">
            <a:avLst>
              <a:gd name="adj1" fmla="val 8333"/>
              <a:gd name="adj2" fmla="val 36477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7" name="Picture 8" descr="https://d30y9cdsu7xlg0.cloudfront.net/png/16266-200.png"/>
          <p:cNvPicPr>
            <a:picLocks noChangeAspect="1" noChangeArrowheads="1"/>
          </p:cNvPicPr>
          <p:nvPr/>
        </p:nvPicPr>
        <p:blipFill>
          <a:blip r:embed="rId10" cstate="print">
            <a:duotone>
              <a:schemeClr val="accent2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36911" y="4576490"/>
            <a:ext cx="753113" cy="7531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2" descr="Coronavirus Test Kit COVID-19 IgG IgM-Pack 40 - C.D.Products S.A-CDP">
            <a:extLst>
              <a:ext uri="{FF2B5EF4-FFF2-40B4-BE49-F238E27FC236}">
                <a16:creationId xmlns:a16="http://schemas.microsoft.com/office/drawing/2014/main" id="{9E2776E3-A3D9-406D-BDEB-FAA1642680A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1" cstate="print">
            <a:duotone>
              <a:schemeClr val="accent1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24" t="4530" r="35268" b="6566"/>
          <a:stretch/>
        </p:blipFill>
        <p:spPr bwMode="auto">
          <a:xfrm>
            <a:off x="6347204" y="5640510"/>
            <a:ext cx="353315" cy="996913"/>
          </a:xfrm>
          <a:prstGeom prst="rect">
            <a:avLst/>
          </a:prstGeom>
          <a:noFill/>
          <a:ln>
            <a:solidFill>
              <a:schemeClr val="accent2">
                <a:lumMod val="75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2" name="Triángulo isósceles 31"/>
          <p:cNvSpPr/>
          <p:nvPr/>
        </p:nvSpPr>
        <p:spPr>
          <a:xfrm rot="5400000">
            <a:off x="5174022" y="5264639"/>
            <a:ext cx="1337197" cy="200985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riángulo isósceles 32"/>
          <p:cNvSpPr/>
          <p:nvPr/>
        </p:nvSpPr>
        <p:spPr>
          <a:xfrm rot="5400000">
            <a:off x="6348367" y="5219859"/>
            <a:ext cx="1337197" cy="200985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riángulo isósceles 33"/>
          <p:cNvSpPr/>
          <p:nvPr/>
        </p:nvSpPr>
        <p:spPr>
          <a:xfrm rot="5400000">
            <a:off x="7660705" y="5254671"/>
            <a:ext cx="1337197" cy="200985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ángulo 34"/>
          <p:cNvSpPr/>
          <p:nvPr/>
        </p:nvSpPr>
        <p:spPr>
          <a:xfrm>
            <a:off x="7409948" y="5921607"/>
            <a:ext cx="703200" cy="36456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MX" sz="900" dirty="0" err="1"/>
              <a:t>Covid</a:t>
            </a:r>
            <a:r>
              <a:rPr lang="es-MX" sz="900" dirty="0"/>
              <a:t> </a:t>
            </a:r>
            <a:r>
              <a:rPr lang="es-MX" sz="900" dirty="0" err="1"/>
              <a:t>Suspected</a:t>
            </a:r>
            <a:endParaRPr lang="en-US" sz="900" dirty="0"/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1AD766BB-E92A-44BF-BDDD-F6ABDF04347A}"/>
              </a:ext>
            </a:extLst>
          </p:cNvPr>
          <p:cNvSpPr txBox="1"/>
          <p:nvPr/>
        </p:nvSpPr>
        <p:spPr>
          <a:xfrm>
            <a:off x="7345049" y="4651753"/>
            <a:ext cx="663964" cy="276999"/>
          </a:xfrm>
          <a:prstGeom prst="rect">
            <a:avLst/>
          </a:prstGeom>
          <a:solidFill>
            <a:srgbClr val="FF0000"/>
          </a:solidFill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Disease</a:t>
            </a: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4CFB3BB6-E534-47B4-AFCC-C59713757735}"/>
              </a:ext>
            </a:extLst>
          </p:cNvPr>
          <p:cNvSpPr txBox="1"/>
          <p:nvPr/>
        </p:nvSpPr>
        <p:spPr>
          <a:xfrm>
            <a:off x="7269770" y="4976758"/>
            <a:ext cx="903965" cy="276999"/>
          </a:xfrm>
          <a:prstGeom prst="rect">
            <a:avLst/>
          </a:prstGeom>
          <a:solidFill>
            <a:schemeClr val="accent4"/>
          </a:solidFill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Pre-disease</a:t>
            </a: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E1E94C5A-9E7A-4DB4-BBDC-63D115CA322B}"/>
              </a:ext>
            </a:extLst>
          </p:cNvPr>
          <p:cNvSpPr txBox="1"/>
          <p:nvPr/>
        </p:nvSpPr>
        <p:spPr>
          <a:xfrm>
            <a:off x="7337092" y="5324699"/>
            <a:ext cx="664284" cy="276999"/>
          </a:xfrm>
          <a:prstGeom prst="rect">
            <a:avLst/>
          </a:prstGeom>
          <a:solidFill>
            <a:schemeClr val="accent6"/>
          </a:solidFill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Healthy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BFCC6772-F530-40B9-B9A5-4ACA272BCA83}"/>
              </a:ext>
            </a:extLst>
          </p:cNvPr>
          <p:cNvSpPr txBox="1"/>
          <p:nvPr/>
        </p:nvSpPr>
        <p:spPr>
          <a:xfrm>
            <a:off x="8478393" y="4900719"/>
            <a:ext cx="16422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dirty="0"/>
              <a:t>MIDO COVID </a:t>
            </a:r>
            <a:r>
              <a:rPr lang="en-US" dirty="0"/>
              <a:t>Report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3C8766A-76A6-4D65-A34E-24C343C996B4}"/>
              </a:ext>
            </a:extLst>
          </p:cNvPr>
          <p:cNvSpPr txBox="1"/>
          <p:nvPr/>
        </p:nvSpPr>
        <p:spPr>
          <a:xfrm>
            <a:off x="0" y="-16544"/>
            <a:ext cx="69734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S1 File: MIDO COVID screening protocol.</a:t>
            </a:r>
          </a:p>
        </p:txBody>
      </p:sp>
    </p:spTree>
    <p:extLst>
      <p:ext uri="{BB962C8B-B14F-4D97-AF65-F5344CB8AC3E}">
        <p14:creationId xmlns:p14="http://schemas.microsoft.com/office/powerpoint/2010/main" val="245396409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</TotalTime>
  <Words>189</Words>
  <Application>Microsoft Office PowerPoint</Application>
  <PresentationFormat>Widescreen</PresentationFormat>
  <Paragraphs>4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lieta Lomelin</dc:creator>
  <cp:lastModifiedBy>Mary Richardson</cp:lastModifiedBy>
  <cp:revision>15</cp:revision>
  <dcterms:created xsi:type="dcterms:W3CDTF">2022-01-07T14:56:00Z</dcterms:created>
  <dcterms:modified xsi:type="dcterms:W3CDTF">2022-01-11T02:38:27Z</dcterms:modified>
</cp:coreProperties>
</file>